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22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67809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6613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57943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29341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75350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78708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09365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59121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04526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58502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801604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E72CA6-4918-44FE-93EE-7D0F96A40576}" type="datetimeFigureOut">
              <a:rPr lang="ru-RU" smtClean="0"/>
              <a:t>15.08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28143-F047-4847-A862-7517CA8D0A6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06635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3" name="Объект 1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102803" y="295000"/>
            <a:ext cx="7583064" cy="5686468"/>
          </a:xfrm>
        </p:spPr>
      </p:pic>
      <p:sp>
        <p:nvSpPr>
          <p:cNvPr id="3" name="TextBox 2"/>
          <p:cNvSpPr txBox="1"/>
          <p:nvPr/>
        </p:nvSpPr>
        <p:spPr>
          <a:xfrm>
            <a:off x="277093" y="6291818"/>
            <a:ext cx="11598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ru-R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inatio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hybrid seeds (F1) obtained via artificial crossing of two parental aspen genotypes </a:t>
            </a:r>
            <a:endParaRPr lang="ru-R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8014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7" name="Объект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063749" y="333902"/>
            <a:ext cx="7749117" cy="5811837"/>
          </a:xfrm>
        </p:spPr>
      </p:pic>
      <p:sp>
        <p:nvSpPr>
          <p:cNvPr id="5" name="TextBox 4"/>
          <p:cNvSpPr txBox="1"/>
          <p:nvPr/>
        </p:nvSpPr>
        <p:spPr>
          <a:xfrm>
            <a:off x="1420093" y="6315075"/>
            <a:ext cx="9064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ru-R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-weeks-old F1 hybrid aspen seedlings placed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lining-out nursery </a:t>
            </a:r>
            <a:endParaRPr lang="ru-R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59906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</TotalTime>
  <Words>39</Words>
  <Application>Microsoft Office PowerPoint</Application>
  <PresentationFormat>Широкоэкранный</PresentationFormat>
  <Paragraphs>2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1: Fig S1</dc:title>
  <dc:creator>Admin</dc:creator>
  <cp:lastModifiedBy>Admin</cp:lastModifiedBy>
  <cp:revision>7</cp:revision>
  <dcterms:created xsi:type="dcterms:W3CDTF">2017-08-03T06:11:14Z</dcterms:created>
  <dcterms:modified xsi:type="dcterms:W3CDTF">2017-08-15T11:30:47Z</dcterms:modified>
</cp:coreProperties>
</file>